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609480" y="368136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623160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431928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802872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60948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431928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802872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609480" y="272520"/>
            <a:ext cx="109713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Bef>
                <a:spcPts val="1426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623160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 fontScale="92000"/>
          </a:bodyPr>
          <a:p>
            <a:pPr marL="315360" indent="0">
              <a:lnSpc>
                <a:spcPct val="93000"/>
              </a:lnSpc>
              <a:spcBef>
                <a:spcPts val="1426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8" name=""/>
          <p:cNvGraphicFramePr/>
          <p:nvPr/>
        </p:nvGraphicFramePr>
        <p:xfrm>
          <a:off x="1185840" y="836640"/>
          <a:ext cx="9740880" cy="3344760"/>
        </p:xfrm>
        <a:graphic>
          <a:graphicData uri="http://schemas.openxmlformats.org/drawingml/2006/table">
            <a:tbl>
              <a:tblPr/>
              <a:tblGrid>
                <a:gridCol w="4859280"/>
                <a:gridCol w="4881600"/>
              </a:tblGrid>
              <a:tr h="419040">
                <a:tc>
                  <a:txBody>
                    <a:bodyPr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CLUSION CRI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s-E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XCLUSION CRITER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25720">
                <a:tc>
                  <a:txBody>
                    <a:bodyPr anchor="t">
                      <a:noAutofit/>
                    </a:bodyPr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e&gt;18 year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rformance status 0-2 at the moment of initiating neodjuvant C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istological diagnosis of an invasive triple negative carcinoma of the breast, after confirmation of ER, PR and HER2 negativity by immunohistochemical technique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age I-II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ients considered candidate for neodjuvant CT and receiving taxanes and/or anthracycline for at least 3 cycles or 3 months if weekly regimens in the neoadjuvant setting was give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vailability of tumor sample archived from biops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vailability of specimen from surgery including RCB index assessme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ppropriate renal and hepatic function for receiving CT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astatic disease at diagno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linical history of primary canc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jor surgical intervention (28 days prior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tive autoimmune disease with immunosuppressive treatment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erious medical or psychiatric illnes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marL="171360" indent="-171360">
                        <a:buClr>
                          <a:srgbClr val="000000"/>
                        </a:buClr>
                        <a:buFont typeface="Arial"/>
                        <a:buChar char="-"/>
                        <a:tabLst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s-E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egnant or lactating wome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9" name="Rectángulo 3"/>
          <p:cNvSpPr/>
          <p:nvPr/>
        </p:nvSpPr>
        <p:spPr>
          <a:xfrm>
            <a:off x="1055520" y="4365720"/>
            <a:ext cx="9871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  <a:ea typeface="Calibri"/>
              </a:rPr>
              <a:t>Table S6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Calibri"/>
              </a:rPr>
              <a:t>: Clinical inclusion and exclusion criteria followed to select TNBC patients for the methylation study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2-11T16:19:16Z</dcterms:created>
  <dc:creator>Angel Diaz Lagares</dc:creator>
  <dc:description/>
  <dc:language>en-US</dc:language>
  <cp:lastModifiedBy>JABELLA</cp:lastModifiedBy>
  <cp:lastPrinted>2018-04-16T13:28:07Z</cp:lastPrinted>
  <dcterms:modified xsi:type="dcterms:W3CDTF">2019-02-01T22:50:44Z</dcterms:modified>
  <cp:revision>176</cp:revision>
  <dc:subject/>
  <dc:title>Presentación de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HiddenSlides">
    <vt:r8>0</vt:r8>
  </property>
  <property fmtid="{D5CDD505-2E9C-101B-9397-08002B2CF9AE}" pid="3" name="HyperlinksChanged">
    <vt:bool>0</vt:bool>
  </property>
  <property fmtid="{D5CDD505-2E9C-101B-9397-08002B2CF9AE}" pid="4" name="LinksUpToDate">
    <vt:bool>0</vt:bool>
  </property>
  <property fmtid="{D5CDD505-2E9C-101B-9397-08002B2CF9AE}" pid="5" name="MMClips">
    <vt:r8>0</vt:r8>
  </property>
  <property fmtid="{D5CDD505-2E9C-101B-9397-08002B2CF9AE}" pid="6" name="Notes">
    <vt:r8>0</vt:r8>
  </property>
  <property fmtid="{D5CDD505-2E9C-101B-9397-08002B2CF9AE}" pid="7" name="PresentationFormat">
    <vt:lpwstr>Panorámica</vt:lpwstr>
  </property>
  <property fmtid="{D5CDD505-2E9C-101B-9397-08002B2CF9AE}" pid="8" name="ScaleCrop">
    <vt:bool>0</vt:bool>
  </property>
  <property fmtid="{D5CDD505-2E9C-101B-9397-08002B2CF9AE}" pid="9" name="ShareDoc">
    <vt:bool>0</vt:bool>
  </property>
  <property fmtid="{D5CDD505-2E9C-101B-9397-08002B2CF9AE}" pid="10" name="Slides">
    <vt:r8>18</vt:r8>
  </property>
</Properties>
</file>